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-1464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484626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30355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271583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357856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143543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203075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328235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494849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204599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916398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852728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946756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79712" y="260648"/>
            <a:ext cx="5715468" cy="48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Rettangolo 3"/>
          <p:cNvSpPr/>
          <p:nvPr/>
        </p:nvSpPr>
        <p:spPr>
          <a:xfrm>
            <a:off x="395536" y="5131058"/>
            <a:ext cx="8424936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focal microscopy analysis of mycobacterial intracellular localization in human macrophage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images of LAMP-1-stained THP-1-derived macrophages infected with GFP expressing H37Rv, TB218 or TB382 at an MOI of 1:1. After 48 h of infection, LAMP-1 compartments were stained in red using anti LAMP-1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ocalizatio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both red and green fluorescence indicates that the mycobacteria reside i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MP-1-associated compartment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overlap is demonstrated in the merged images, where yellow indicates a positive correlation. Boxed areas show enlargements of sections of interest with examples of negative (H37Rv and TB318) and positive (TB218)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ocalizatio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Images were taken with a Leica T CSNT/SP2 confocal microscope using a x63 oil immersion objective. To calculate the percentage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ocalizatio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each coverslip, the superposition of fluorescence for a minimum of 100 internalized isolated bacteria was analyzed. At least two slides were analyzed from each of three independent infections.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38518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2</Words>
  <Application>Microsoft Office PowerPoint</Application>
  <PresentationFormat>Presentazione su schermo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Riccardo</dc:creator>
  <cp:lastModifiedBy>Riccardo</cp:lastModifiedBy>
  <cp:revision>3</cp:revision>
  <dcterms:created xsi:type="dcterms:W3CDTF">2014-09-09T22:22:12Z</dcterms:created>
  <dcterms:modified xsi:type="dcterms:W3CDTF">2014-09-09T22:24:29Z</dcterms:modified>
</cp:coreProperties>
</file>